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notesSlides/notesSlide1.xml" ContentType="application/vnd.openxmlformats-officedocument.presentationml.notesSlide+xml"/>
  <Override PartName="/ppt/charts/chart17.xml" ContentType="application/vnd.openxmlformats-officedocument.drawingml.chart+xml"/>
  <Override PartName="/ppt/drawings/drawing1.xml" ContentType="application/vnd.openxmlformats-officedocument.drawingml.chartshapes+xml"/>
  <Override PartName="/ppt/charts/chart1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5" r:id="rId2"/>
    <p:sldId id="286" r:id="rId3"/>
    <p:sldId id="287" r:id="rId4"/>
    <p:sldId id="288" r:id="rId5"/>
    <p:sldId id="289" r:id="rId6"/>
    <p:sldId id="294" r:id="rId7"/>
    <p:sldId id="269" r:id="rId8"/>
    <p:sldId id="295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78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I:\NEw%20QPCr%20submission\MS_parted_qPCR_expression%20Recalculated%20and%20Checke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0944235\Desktop\qPCR_expression_Graphs_12th_May20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RPL19 -</a:t>
            </a:r>
            <a:r>
              <a:rPr lang="en-US" sz="1400" baseline="0" dirty="0"/>
              <a:t> </a:t>
            </a:r>
            <a:r>
              <a:rPr lang="en-US" sz="1400" b="1" i="0" u="none" strike="noStrike" baseline="0" dirty="0">
                <a:effectLst/>
              </a:rPr>
              <a:t>Standard Curve  </a:t>
            </a:r>
            <a:endParaRPr lang="en-US" sz="1400" dirty="0"/>
          </a:p>
        </c:rich>
      </c:tx>
      <c:layout>
        <c:manualLayout>
          <c:xMode val="edge"/>
          <c:yMode val="edge"/>
          <c:x val="0.18572612559886301"/>
          <c:y val="4.660763125330050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4172559931464503E-2"/>
          <c:y val="4.9992572130990003E-2"/>
          <c:w val="0.76618898165396798"/>
          <c:h val="0.79221403852583805"/>
        </c:manualLayout>
      </c:layout>
      <c:scatterChart>
        <c:scatterStyle val="lineMarker"/>
        <c:varyColors val="0"/>
        <c:ser>
          <c:idx val="1"/>
          <c:order val="0"/>
          <c:tx>
            <c:strRef>
              <c:f>'Pool graphs '!$A$4</c:f>
              <c:strCache>
                <c:ptCount val="1"/>
                <c:pt idx="0">
                  <c:v>Ct-Pool-RPl19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1.23142156277784E-2"/>
                  <c:y val="7.02478703591565E-2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4:$I$4</c:f>
              <c:numCache>
                <c:formatCode>General</c:formatCode>
                <c:ptCount val="8"/>
                <c:pt idx="0">
                  <c:v>19.64</c:v>
                </c:pt>
                <c:pt idx="4">
                  <c:v>24.57</c:v>
                </c:pt>
                <c:pt idx="5">
                  <c:v>25.47</c:v>
                </c:pt>
                <c:pt idx="6">
                  <c:v>26.89</c:v>
                </c:pt>
                <c:pt idx="7">
                  <c:v>28.01</c:v>
                </c:pt>
              </c:numCache>
            </c:numRef>
          </c:yVal>
          <c:smooth val="0"/>
        </c:ser>
        <c:ser>
          <c:idx val="0"/>
          <c:order val="1"/>
          <c:tx>
            <c:strRef>
              <c:f>'Pool graphs '!$A$3</c:f>
              <c:strCache>
                <c:ptCount val="1"/>
                <c:pt idx="0">
                  <c:v>Ct-Pool-RPl19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3:$I$3</c:f>
              <c:numCache>
                <c:formatCode>General</c:formatCode>
                <c:ptCount val="8"/>
                <c:pt idx="0">
                  <c:v>19.55</c:v>
                </c:pt>
                <c:pt idx="4">
                  <c:v>24.42</c:v>
                </c:pt>
                <c:pt idx="5">
                  <c:v>25.42</c:v>
                </c:pt>
                <c:pt idx="6">
                  <c:v>26.88</c:v>
                </c:pt>
                <c:pt idx="7">
                  <c:v>28.0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Pool graphs '!$A$5</c:f>
              <c:strCache>
                <c:ptCount val="1"/>
                <c:pt idx="0">
                  <c:v>Ct-Pool-RPl19-3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5:$I$5</c:f>
              <c:numCache>
                <c:formatCode>General</c:formatCode>
                <c:ptCount val="8"/>
                <c:pt idx="0">
                  <c:v>19.07</c:v>
                </c:pt>
                <c:pt idx="4">
                  <c:v>24</c:v>
                </c:pt>
                <c:pt idx="5">
                  <c:v>25.45</c:v>
                </c:pt>
                <c:pt idx="6">
                  <c:v>26.6</c:v>
                </c:pt>
                <c:pt idx="7">
                  <c:v>27.6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Pool graphs '!$A$6</c:f>
              <c:strCache>
                <c:ptCount val="1"/>
                <c:pt idx="0">
                  <c:v>Ct-Pool-RPl19-4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</c:marke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6:$I$6</c:f>
              <c:numCache>
                <c:formatCode>General</c:formatCode>
                <c:ptCount val="8"/>
                <c:pt idx="0">
                  <c:v>18.84</c:v>
                </c:pt>
                <c:pt idx="4">
                  <c:v>23.99</c:v>
                </c:pt>
                <c:pt idx="5">
                  <c:v>25.43</c:v>
                </c:pt>
                <c:pt idx="6">
                  <c:v>26.82</c:v>
                </c:pt>
                <c:pt idx="7">
                  <c:v>27.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5108352"/>
        <c:axId val="145139584"/>
      </c:scatterChart>
      <c:valAx>
        <c:axId val="145108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of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5139584"/>
        <c:crosses val="autoZero"/>
        <c:crossBetween val="midCat"/>
      </c:valAx>
      <c:valAx>
        <c:axId val="145139584"/>
        <c:scaling>
          <c:orientation val="minMax"/>
          <c:max val="35"/>
          <c:min val="1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</a:t>
                </a:r>
                <a:r>
                  <a:rPr lang="en-US" baseline="0"/>
                  <a:t> Value 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81547016351141"/>
              <c:y val="0.36988784128668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45108352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76685661297888"/>
          <c:y val="4.9433759223558291E-2"/>
          <c:w val="0.166511718058623"/>
          <c:h val="0.90355710147970636"/>
        </c:manualLayout>
      </c:layout>
      <c:overlay val="1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GAG Clade 3-C 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50</c:f>
              <c:strCache>
                <c:ptCount val="1"/>
                <c:pt idx="0">
                  <c:v>Ct-Pool-GAG Clade 3-C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50:$I$50</c:f>
              <c:numCache>
                <c:formatCode>General</c:formatCode>
                <c:ptCount val="8"/>
                <c:pt idx="3">
                  <c:v>22.07</c:v>
                </c:pt>
                <c:pt idx="4">
                  <c:v>23.65</c:v>
                </c:pt>
                <c:pt idx="6">
                  <c:v>25.1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51</c:f>
              <c:strCache>
                <c:ptCount val="1"/>
                <c:pt idx="0">
                  <c:v>Ct-Pool-GAG Clade 3-C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0.28027506561679799"/>
                  <c:y val="-0.39336183620005299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51:$I$51</c:f>
              <c:numCache>
                <c:formatCode>General</c:formatCode>
                <c:ptCount val="8"/>
                <c:pt idx="3">
                  <c:v>21.97</c:v>
                </c:pt>
                <c:pt idx="4">
                  <c:v>23.65</c:v>
                </c:pt>
                <c:pt idx="6">
                  <c:v>25.1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968320"/>
        <c:axId val="164982784"/>
      </c:scatterChart>
      <c:valAx>
        <c:axId val="1649683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4982784"/>
        <c:crosses val="autoZero"/>
        <c:crossBetween val="midCat"/>
      </c:valAx>
      <c:valAx>
        <c:axId val="164982784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4968320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6.1585207254498599E-2"/>
          <c:w val="0.16629491525613099"/>
          <c:h val="0.80936513941763299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ENV Clade 1-A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55</c:f>
              <c:strCache>
                <c:ptCount val="1"/>
                <c:pt idx="0">
                  <c:v>Ct-Pool-ENV Clade 1-A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55:$I$55</c:f>
              <c:numCache>
                <c:formatCode>General</c:formatCode>
                <c:ptCount val="8"/>
                <c:pt idx="0">
                  <c:v>22.67</c:v>
                </c:pt>
                <c:pt idx="1">
                  <c:v>24.63</c:v>
                </c:pt>
                <c:pt idx="2">
                  <c:v>25.4</c:v>
                </c:pt>
                <c:pt idx="4">
                  <c:v>27.03</c:v>
                </c:pt>
                <c:pt idx="5">
                  <c:v>32.8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56</c:f>
              <c:strCache>
                <c:ptCount val="1"/>
                <c:pt idx="0">
                  <c:v>Ct-Pool-ENV Clade 1-A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0.28027506561679799"/>
                  <c:y val="-0.39336183620005299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56:$I$56</c:f>
              <c:numCache>
                <c:formatCode>General</c:formatCode>
                <c:ptCount val="8"/>
                <c:pt idx="0">
                  <c:v>23.12</c:v>
                </c:pt>
                <c:pt idx="1">
                  <c:v>24.83</c:v>
                </c:pt>
                <c:pt idx="2">
                  <c:v>25.36</c:v>
                </c:pt>
                <c:pt idx="4">
                  <c:v>27.22</c:v>
                </c:pt>
                <c:pt idx="5">
                  <c:v>28.1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038336"/>
        <c:axId val="165044608"/>
      </c:scatterChart>
      <c:valAx>
        <c:axId val="1650383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044608"/>
        <c:crosses val="autoZero"/>
        <c:crossBetween val="midCat"/>
      </c:valAx>
      <c:valAx>
        <c:axId val="165044608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5038336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6.9926882262840301E-2"/>
          <c:w val="0.16629491525613099"/>
          <c:h val="0.79268178940094902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ENV-Clade 1-B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60</c:f>
              <c:strCache>
                <c:ptCount val="1"/>
                <c:pt idx="0">
                  <c:v>Ct-Pool-ENV Clade 1-B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60:$I$60</c:f>
              <c:numCache>
                <c:formatCode>General</c:formatCode>
                <c:ptCount val="8"/>
                <c:pt idx="1">
                  <c:v>25.58</c:v>
                </c:pt>
                <c:pt idx="2">
                  <c:v>27.57</c:v>
                </c:pt>
                <c:pt idx="3">
                  <c:v>28.2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61</c:f>
              <c:strCache>
                <c:ptCount val="1"/>
                <c:pt idx="0">
                  <c:v>Ct-Pool-ENV Clade 1-B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0.28192241028001302"/>
                  <c:y val="-0.21748786664824801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61:$I$61</c:f>
              <c:numCache>
                <c:formatCode>General</c:formatCode>
                <c:ptCount val="8"/>
                <c:pt idx="1">
                  <c:v>25.96</c:v>
                </c:pt>
                <c:pt idx="2">
                  <c:v>27.45</c:v>
                </c:pt>
                <c:pt idx="3">
                  <c:v>28.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067008"/>
        <c:axId val="165073280"/>
      </c:scatterChart>
      <c:valAx>
        <c:axId val="1650670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073280"/>
        <c:crosses val="autoZero"/>
        <c:crossBetween val="midCat"/>
      </c:valAx>
      <c:valAx>
        <c:axId val="165073280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5067008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5.74143697503278E-2"/>
          <c:w val="0.15911997842637601"/>
          <c:h val="0.89639968052041596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ENV Clade 2 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65</c:f>
              <c:strCache>
                <c:ptCount val="1"/>
                <c:pt idx="0">
                  <c:v>Ct-Pool-ENV Clade 2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65:$I$65</c:f>
              <c:numCache>
                <c:formatCode>General</c:formatCode>
                <c:ptCount val="8"/>
                <c:pt idx="0">
                  <c:v>22.85</c:v>
                </c:pt>
                <c:pt idx="1">
                  <c:v>24.58</c:v>
                </c:pt>
                <c:pt idx="2">
                  <c:v>25.4</c:v>
                </c:pt>
                <c:pt idx="4">
                  <c:v>27.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66</c:f>
              <c:strCache>
                <c:ptCount val="1"/>
                <c:pt idx="0">
                  <c:v>Ct-Pool-ENV Clade 2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1.8988393156611601E-2"/>
                  <c:y val="-0.36122488546714798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66:$I$66</c:f>
              <c:numCache>
                <c:formatCode>General</c:formatCode>
                <c:ptCount val="8"/>
                <c:pt idx="0">
                  <c:v>23.05</c:v>
                </c:pt>
                <c:pt idx="1">
                  <c:v>24.83</c:v>
                </c:pt>
                <c:pt idx="2">
                  <c:v>25.28</c:v>
                </c:pt>
                <c:pt idx="4">
                  <c:v>27.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107968"/>
        <c:axId val="165122432"/>
      </c:scatterChart>
      <c:valAx>
        <c:axId val="1651079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122432"/>
        <c:crosses val="autoZero"/>
        <c:crossBetween val="midCat"/>
      </c:valAx>
      <c:valAx>
        <c:axId val="165122432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5107968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6.1585207254498599E-2"/>
          <c:w val="0.16629491525613099"/>
          <c:h val="0.80519430191346197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ENV-Clade 3-A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70</c:f>
              <c:strCache>
                <c:ptCount val="1"/>
                <c:pt idx="0">
                  <c:v>Ct-Pool-ENV Clade 3-A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70:$I$70</c:f>
              <c:numCache>
                <c:formatCode>General</c:formatCode>
                <c:ptCount val="8"/>
                <c:pt idx="0">
                  <c:v>21.96</c:v>
                </c:pt>
                <c:pt idx="2">
                  <c:v>24.36</c:v>
                </c:pt>
                <c:pt idx="4">
                  <c:v>26.8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71</c:f>
              <c:strCache>
                <c:ptCount val="1"/>
                <c:pt idx="0">
                  <c:v>Ct-Pool-ENV Clade 3-A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0.28192241028001302"/>
                  <c:y val="-0.21748786664824801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71:$I$71</c:f>
              <c:numCache>
                <c:formatCode>General</c:formatCode>
                <c:ptCount val="8"/>
                <c:pt idx="0">
                  <c:v>21.85</c:v>
                </c:pt>
                <c:pt idx="2">
                  <c:v>24.68</c:v>
                </c:pt>
                <c:pt idx="4">
                  <c:v>26.4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157504"/>
        <c:axId val="165163776"/>
      </c:scatterChart>
      <c:valAx>
        <c:axId val="1651575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163776"/>
        <c:crosses val="autoZero"/>
        <c:crossBetween val="midCat"/>
      </c:valAx>
      <c:valAx>
        <c:axId val="165163776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5157504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6.9926882262840301E-2"/>
          <c:w val="0.15911997842637601"/>
          <c:h val="0.88388716800790301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ENV Clade 3-B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75</c:f>
              <c:strCache>
                <c:ptCount val="1"/>
                <c:pt idx="0">
                  <c:v>Ct-Pool-ENV Clade 3-B 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75:$I$75</c:f>
              <c:numCache>
                <c:formatCode>General</c:formatCode>
                <c:ptCount val="8"/>
                <c:pt idx="0">
                  <c:v>21.85</c:v>
                </c:pt>
                <c:pt idx="1">
                  <c:v>24.58</c:v>
                </c:pt>
                <c:pt idx="2">
                  <c:v>25.4</c:v>
                </c:pt>
                <c:pt idx="4">
                  <c:v>27.5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76</c:f>
              <c:strCache>
                <c:ptCount val="1"/>
                <c:pt idx="0">
                  <c:v>Ct-Pool-ENV Clade 3-B 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0.28192241028001302"/>
                  <c:y val="-0.21748786664824801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76:$I$76</c:f>
              <c:numCache>
                <c:formatCode>General</c:formatCode>
                <c:ptCount val="8"/>
                <c:pt idx="0">
                  <c:v>22.45</c:v>
                </c:pt>
                <c:pt idx="1">
                  <c:v>24.26</c:v>
                </c:pt>
                <c:pt idx="2">
                  <c:v>25.01</c:v>
                </c:pt>
                <c:pt idx="4">
                  <c:v>27.2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190272"/>
        <c:axId val="165192448"/>
      </c:scatterChart>
      <c:valAx>
        <c:axId val="1651902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192448"/>
        <c:crosses val="autoZero"/>
        <c:crossBetween val="midCat"/>
      </c:valAx>
      <c:valAx>
        <c:axId val="165192448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5190272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1544526196409395"/>
          <c:y val="0.10746441980037801"/>
          <c:w val="0.15911997842637601"/>
          <c:h val="0.89222884301624505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ENV MSRV (HERV-W) -Standard Curve</a:t>
            </a:r>
            <a:endParaRPr lang="en-US" sz="1400" b="1"/>
          </a:p>
        </c:rich>
      </c:tx>
      <c:layout>
        <c:manualLayout>
          <c:xMode val="edge"/>
          <c:yMode val="edge"/>
          <c:x val="0.11386871779916399"/>
          <c:y val="3.9621642640015303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80</c:f>
              <c:strCache>
                <c:ptCount val="1"/>
                <c:pt idx="0">
                  <c:v>Ct-Pool-MSRV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80:$I$80</c:f>
              <c:numCache>
                <c:formatCode>General</c:formatCode>
                <c:ptCount val="8"/>
                <c:pt idx="1">
                  <c:v>28.76</c:v>
                </c:pt>
                <c:pt idx="2">
                  <c:v>29.95</c:v>
                </c:pt>
                <c:pt idx="3">
                  <c:v>30.04</c:v>
                </c:pt>
                <c:pt idx="6">
                  <c:v>33.47</c:v>
                </c:pt>
                <c:pt idx="7">
                  <c:v>35.5200000000000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81</c:f>
              <c:strCache>
                <c:ptCount val="1"/>
                <c:pt idx="0">
                  <c:v>Ct-Pool-MSRV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0.28265314389271301"/>
                  <c:y val="-3.9901347825811097E-2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81:$I$81</c:f>
              <c:numCache>
                <c:formatCode>General</c:formatCode>
                <c:ptCount val="8"/>
                <c:pt idx="1">
                  <c:v>29.03</c:v>
                </c:pt>
                <c:pt idx="2">
                  <c:v>30.13</c:v>
                </c:pt>
                <c:pt idx="3">
                  <c:v>30.42</c:v>
                </c:pt>
                <c:pt idx="6">
                  <c:v>32.880000000000003</c:v>
                </c:pt>
                <c:pt idx="7">
                  <c:v>36.4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399168"/>
        <c:axId val="165741312"/>
      </c:scatterChart>
      <c:valAx>
        <c:axId val="1653991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741312"/>
        <c:crosses val="autoZero"/>
        <c:crossBetween val="midCat"/>
      </c:valAx>
      <c:valAx>
        <c:axId val="165741312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5399168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6.5756044758669405E-2"/>
          <c:w val="0.15911997842637601"/>
          <c:h val="0.88805800551207403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rgbClr val="0000FF"/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6"/>
              <c:layout>
                <c:manualLayout>
                  <c:x val="-4.2372881355932203E-3"/>
                  <c:y val="4.3290043290043299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200">
                    <a:latin typeface="Arial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B$2:$B$14</c:f>
              <c:strCache>
                <c:ptCount val="13"/>
                <c:pt idx="0">
                  <c:v>GAG Clade 1-A</c:v>
                </c:pt>
                <c:pt idx="1">
                  <c:v>GAG Clade 1-B</c:v>
                </c:pt>
                <c:pt idx="2">
                  <c:v>GAG Clade 1-C</c:v>
                </c:pt>
                <c:pt idx="3">
                  <c:v>GAG Clade 2</c:v>
                </c:pt>
                <c:pt idx="4">
                  <c:v>GAG Clade 3-A</c:v>
                </c:pt>
                <c:pt idx="5">
                  <c:v>GAG Clade 3-B</c:v>
                </c:pt>
                <c:pt idx="6">
                  <c:v>GAG Clade 3-C</c:v>
                </c:pt>
                <c:pt idx="7">
                  <c:v>ENV Clade 1-A</c:v>
                </c:pt>
                <c:pt idx="8">
                  <c:v>ENV Clade 1-B</c:v>
                </c:pt>
                <c:pt idx="9">
                  <c:v>ENV Clade 2</c:v>
                </c:pt>
                <c:pt idx="10">
                  <c:v>ENV Clade 3-A</c:v>
                </c:pt>
                <c:pt idx="11">
                  <c:v>ENV Clade 3-B</c:v>
                </c:pt>
                <c:pt idx="12">
                  <c:v>ENV MSRV (HERV-W)</c:v>
                </c:pt>
              </c:strCache>
            </c:strRef>
          </c:cat>
          <c:val>
            <c:numRef>
              <c:f>Sheet1!$C$2:$C$14</c:f>
              <c:numCache>
                <c:formatCode>0.000</c:formatCode>
                <c:ptCount val="13"/>
                <c:pt idx="0">
                  <c:v>9.7458026386728805E-2</c:v>
                </c:pt>
                <c:pt idx="1">
                  <c:v>8.7369793376458296E-2</c:v>
                </c:pt>
                <c:pt idx="2">
                  <c:v>-6.9943933069689102E-3</c:v>
                </c:pt>
                <c:pt idx="3">
                  <c:v>0.13443596972692001</c:v>
                </c:pt>
                <c:pt idx="4">
                  <c:v>-0.42291962328857302</c:v>
                </c:pt>
                <c:pt idx="5">
                  <c:v>0.32774805811496799</c:v>
                </c:pt>
                <c:pt idx="6">
                  <c:v>0.14501565282317</c:v>
                </c:pt>
                <c:pt idx="7">
                  <c:v>-0.320281015088766</c:v>
                </c:pt>
                <c:pt idx="8">
                  <c:v>0.104277106032394</c:v>
                </c:pt>
                <c:pt idx="9">
                  <c:v>0.41648456401207701</c:v>
                </c:pt>
                <c:pt idx="10">
                  <c:v>0.27473854735895797</c:v>
                </c:pt>
                <c:pt idx="11">
                  <c:v>0.35136069104772999</c:v>
                </c:pt>
                <c:pt idx="12">
                  <c:v>0.212466247307635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68635776"/>
        <c:axId val="169490688"/>
      </c:barChart>
      <c:catAx>
        <c:axId val="168635776"/>
        <c:scaling>
          <c:orientation val="minMax"/>
        </c:scaling>
        <c:delete val="0"/>
        <c:axPos val="b"/>
        <c:majorTickMark val="none"/>
        <c:minorTickMark val="none"/>
        <c:tickLblPos val="low"/>
        <c:txPr>
          <a:bodyPr/>
          <a:lstStyle/>
          <a:p>
            <a:pPr>
              <a:defRPr sz="1200" b="1" i="0" baseline="0">
                <a:latin typeface="Arial"/>
              </a:defRPr>
            </a:pPr>
            <a:endParaRPr lang="en-US"/>
          </a:p>
        </c:txPr>
        <c:crossAx val="169490688"/>
        <c:crosses val="autoZero"/>
        <c:auto val="1"/>
        <c:lblAlgn val="ctr"/>
        <c:lblOffset val="100"/>
        <c:noMultiLvlLbl val="0"/>
      </c:catAx>
      <c:valAx>
        <c:axId val="169490688"/>
        <c:scaling>
          <c:orientation val="minMax"/>
          <c:max val="0.6"/>
          <c:min val="-0.6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Fold</a:t>
                </a:r>
                <a:r>
                  <a:rPr lang="en-US" baseline="0" dirty="0" smtClean="0"/>
                  <a:t> Change (log</a:t>
                </a:r>
                <a:r>
                  <a:rPr lang="en-US" baseline="-25000" dirty="0" smtClean="0"/>
                  <a:t>2</a:t>
                </a:r>
                <a:r>
                  <a:rPr lang="en-US" baseline="0" dirty="0" smtClean="0"/>
                  <a:t>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1.41242937853107E-2"/>
              <c:y val="0.27833708286464198"/>
            </c:manualLayout>
          </c:layout>
          <c:overlay val="0"/>
        </c:title>
        <c:numFmt formatCode="0.000" sourceLinked="1"/>
        <c:majorTickMark val="out"/>
        <c:minorTickMark val="none"/>
        <c:tickLblPos val="nextTo"/>
        <c:txPr>
          <a:bodyPr/>
          <a:lstStyle/>
          <a:p>
            <a:pPr>
              <a:defRPr sz="1200" b="0" i="0" baseline="0">
                <a:latin typeface="Arial"/>
              </a:defRPr>
            </a:pPr>
            <a:endParaRPr lang="en-US"/>
          </a:p>
        </c:txPr>
        <c:crossAx val="168635776"/>
        <c:crosses val="autoZero"/>
        <c:crossBetween val="between"/>
        <c:majorUnit val="0.2"/>
        <c:minorUnit val="0.0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  <c:userShapes r:id="rId2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HERV</a:t>
            </a:r>
            <a:r>
              <a:rPr lang="en-US" baseline="0" dirty="0"/>
              <a:t> expression (Median) in types of </a:t>
            </a:r>
            <a:r>
              <a:rPr lang="en-US" baseline="0" dirty="0" smtClean="0"/>
              <a:t>types of brain </a:t>
            </a:r>
            <a:r>
              <a:rPr lang="en-US" baseline="0" dirty="0"/>
              <a:t>samples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ERV expression in MS types '!$A$2</c:f>
              <c:strCache>
                <c:ptCount val="1"/>
                <c:pt idx="0">
                  <c:v>Control Brain</c:v>
                </c:pt>
              </c:strCache>
            </c:strRef>
          </c:tx>
          <c:invertIfNegative val="0"/>
          <c:cat>
            <c:strRef>
              <c:f>'HERV expression in MS types '!$C$1:$O$1</c:f>
              <c:strCache>
                <c:ptCount val="13"/>
                <c:pt idx="0">
                  <c:v>GAG Clade 1-A </c:v>
                </c:pt>
                <c:pt idx="1">
                  <c:v>GAG Clade 1-B </c:v>
                </c:pt>
                <c:pt idx="2">
                  <c:v>GAG Clade 1-C </c:v>
                </c:pt>
                <c:pt idx="3">
                  <c:v>GAG Clade 2 </c:v>
                </c:pt>
                <c:pt idx="4">
                  <c:v>GAG Clade 3-AExpression</c:v>
                </c:pt>
                <c:pt idx="5">
                  <c:v>GAG Clade 3-B Norm</c:v>
                </c:pt>
                <c:pt idx="6">
                  <c:v>GAG Clade 3-C </c:v>
                </c:pt>
                <c:pt idx="7">
                  <c:v>ENV Clade 1-A Norm</c:v>
                </c:pt>
                <c:pt idx="8">
                  <c:v>ENV Clade 1-B</c:v>
                </c:pt>
                <c:pt idx="9">
                  <c:v>ENV Clade 2 </c:v>
                </c:pt>
                <c:pt idx="10">
                  <c:v>ENV Clade 3-A </c:v>
                </c:pt>
                <c:pt idx="11">
                  <c:v>ENV Clade 3-B</c:v>
                </c:pt>
                <c:pt idx="12">
                  <c:v>MSRV </c:v>
                </c:pt>
              </c:strCache>
            </c:strRef>
          </c:cat>
          <c:val>
            <c:numRef>
              <c:f>'HERV expression in MS types '!$C$2:$O$2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1"/>
          <c:order val="1"/>
          <c:tx>
            <c:strRef>
              <c:f>'HERV expression in MS types '!$A$3</c:f>
              <c:strCache>
                <c:ptCount val="1"/>
                <c:pt idx="0">
                  <c:v>Chronic Progressive MS</c:v>
                </c:pt>
              </c:strCache>
            </c:strRef>
          </c:tx>
          <c:invertIfNegative val="0"/>
          <c:cat>
            <c:strRef>
              <c:f>'HERV expression in MS types '!$C$1:$O$1</c:f>
              <c:strCache>
                <c:ptCount val="13"/>
                <c:pt idx="0">
                  <c:v>GAG Clade 1-A </c:v>
                </c:pt>
                <c:pt idx="1">
                  <c:v>GAG Clade 1-B </c:v>
                </c:pt>
                <c:pt idx="2">
                  <c:v>GAG Clade 1-C </c:v>
                </c:pt>
                <c:pt idx="3">
                  <c:v>GAG Clade 2 </c:v>
                </c:pt>
                <c:pt idx="4">
                  <c:v>GAG Clade 3-AExpression</c:v>
                </c:pt>
                <c:pt idx="5">
                  <c:v>GAG Clade 3-B Norm</c:v>
                </c:pt>
                <c:pt idx="6">
                  <c:v>GAG Clade 3-C </c:v>
                </c:pt>
                <c:pt idx="7">
                  <c:v>ENV Clade 1-A Norm</c:v>
                </c:pt>
                <c:pt idx="8">
                  <c:v>ENV Clade 1-B</c:v>
                </c:pt>
                <c:pt idx="9">
                  <c:v>ENV Clade 2 </c:v>
                </c:pt>
                <c:pt idx="10">
                  <c:v>ENV Clade 3-A </c:v>
                </c:pt>
                <c:pt idx="11">
                  <c:v>ENV Clade 3-B</c:v>
                </c:pt>
                <c:pt idx="12">
                  <c:v>MSRV </c:v>
                </c:pt>
              </c:strCache>
            </c:strRef>
          </c:cat>
          <c:val>
            <c:numRef>
              <c:f>'HERV expression in MS types '!$C$3:$O$3</c:f>
              <c:numCache>
                <c:formatCode>General</c:formatCode>
                <c:ptCount val="13"/>
                <c:pt idx="0">
                  <c:v>-6.1941893952418108E-3</c:v>
                </c:pt>
                <c:pt idx="1">
                  <c:v>-1.6684789750672419E-2</c:v>
                </c:pt>
                <c:pt idx="2">
                  <c:v>-0.10173256362872619</c:v>
                </c:pt>
                <c:pt idx="3">
                  <c:v>0.18479965652220856</c:v>
                </c:pt>
                <c:pt idx="4">
                  <c:v>-0.49544074654470605</c:v>
                </c:pt>
                <c:pt idx="5">
                  <c:v>0.24839905575791443</c:v>
                </c:pt>
                <c:pt idx="6">
                  <c:v>8.65692988898214E-2</c:v>
                </c:pt>
                <c:pt idx="7">
                  <c:v>-0.55230576683894128</c:v>
                </c:pt>
                <c:pt idx="8">
                  <c:v>0.18572707146140699</c:v>
                </c:pt>
                <c:pt idx="9">
                  <c:v>0.24036555983166685</c:v>
                </c:pt>
                <c:pt idx="10">
                  <c:v>0.30367362751922256</c:v>
                </c:pt>
                <c:pt idx="11">
                  <c:v>0.39968184090812453</c:v>
                </c:pt>
                <c:pt idx="12">
                  <c:v>0.31066674539083278</c:v>
                </c:pt>
              </c:numCache>
            </c:numRef>
          </c:val>
        </c:ser>
        <c:ser>
          <c:idx val="2"/>
          <c:order val="2"/>
          <c:tx>
            <c:strRef>
              <c:f>'HERV expression in MS types '!$A$4</c:f>
              <c:strCache>
                <c:ptCount val="1"/>
                <c:pt idx="0">
                  <c:v>Primary Progressive MS</c:v>
                </c:pt>
              </c:strCache>
            </c:strRef>
          </c:tx>
          <c:invertIfNegative val="0"/>
          <c:cat>
            <c:strRef>
              <c:f>'HERV expression in MS types '!$C$1:$O$1</c:f>
              <c:strCache>
                <c:ptCount val="13"/>
                <c:pt idx="0">
                  <c:v>GAG Clade 1-A </c:v>
                </c:pt>
                <c:pt idx="1">
                  <c:v>GAG Clade 1-B </c:v>
                </c:pt>
                <c:pt idx="2">
                  <c:v>GAG Clade 1-C </c:v>
                </c:pt>
                <c:pt idx="3">
                  <c:v>GAG Clade 2 </c:v>
                </c:pt>
                <c:pt idx="4">
                  <c:v>GAG Clade 3-AExpression</c:v>
                </c:pt>
                <c:pt idx="5">
                  <c:v>GAG Clade 3-B Norm</c:v>
                </c:pt>
                <c:pt idx="6">
                  <c:v>GAG Clade 3-C </c:v>
                </c:pt>
                <c:pt idx="7">
                  <c:v>ENV Clade 1-A Norm</c:v>
                </c:pt>
                <c:pt idx="8">
                  <c:v>ENV Clade 1-B</c:v>
                </c:pt>
                <c:pt idx="9">
                  <c:v>ENV Clade 2 </c:v>
                </c:pt>
                <c:pt idx="10">
                  <c:v>ENV Clade 3-A </c:v>
                </c:pt>
                <c:pt idx="11">
                  <c:v>ENV Clade 3-B</c:v>
                </c:pt>
                <c:pt idx="12">
                  <c:v>MSRV </c:v>
                </c:pt>
              </c:strCache>
            </c:strRef>
          </c:cat>
          <c:val>
            <c:numRef>
              <c:f>'HERV expression in MS types '!$C$4:$O$4</c:f>
              <c:numCache>
                <c:formatCode>General</c:formatCode>
                <c:ptCount val="13"/>
                <c:pt idx="0">
                  <c:v>-1.8858618105368829E-2</c:v>
                </c:pt>
                <c:pt idx="1">
                  <c:v>3.2490075817418182E-2</c:v>
                </c:pt>
                <c:pt idx="2">
                  <c:v>-2.4513616518653455E-2</c:v>
                </c:pt>
                <c:pt idx="3">
                  <c:v>3.1274947030420178E-2</c:v>
                </c:pt>
                <c:pt idx="4">
                  <c:v>-0.51834602941856422</c:v>
                </c:pt>
                <c:pt idx="5">
                  <c:v>0.37277727852627196</c:v>
                </c:pt>
                <c:pt idx="6">
                  <c:v>0.10066996890090324</c:v>
                </c:pt>
                <c:pt idx="7">
                  <c:v>-0.33346839544077322</c:v>
                </c:pt>
                <c:pt idx="8">
                  <c:v>2.343168533835624E-2</c:v>
                </c:pt>
                <c:pt idx="9">
                  <c:v>0.48428838408068597</c:v>
                </c:pt>
                <c:pt idx="10">
                  <c:v>0.2060978077625438</c:v>
                </c:pt>
                <c:pt idx="11">
                  <c:v>0.18570822574896328</c:v>
                </c:pt>
                <c:pt idx="12">
                  <c:v>0.21336255475254179</c:v>
                </c:pt>
              </c:numCache>
            </c:numRef>
          </c:val>
        </c:ser>
        <c:ser>
          <c:idx val="3"/>
          <c:order val="3"/>
          <c:tx>
            <c:strRef>
              <c:f>'HERV expression in MS types '!$A$5</c:f>
              <c:strCache>
                <c:ptCount val="1"/>
                <c:pt idx="0">
                  <c:v>Secondary Progressive MS</c:v>
                </c:pt>
              </c:strCache>
            </c:strRef>
          </c:tx>
          <c:invertIfNegative val="0"/>
          <c:cat>
            <c:strRef>
              <c:f>'HERV expression in MS types '!$C$1:$O$1</c:f>
              <c:strCache>
                <c:ptCount val="13"/>
                <c:pt idx="0">
                  <c:v>GAG Clade 1-A </c:v>
                </c:pt>
                <c:pt idx="1">
                  <c:v>GAG Clade 1-B </c:v>
                </c:pt>
                <c:pt idx="2">
                  <c:v>GAG Clade 1-C </c:v>
                </c:pt>
                <c:pt idx="3">
                  <c:v>GAG Clade 2 </c:v>
                </c:pt>
                <c:pt idx="4">
                  <c:v>GAG Clade 3-AExpression</c:v>
                </c:pt>
                <c:pt idx="5">
                  <c:v>GAG Clade 3-B Norm</c:v>
                </c:pt>
                <c:pt idx="6">
                  <c:v>GAG Clade 3-C </c:v>
                </c:pt>
                <c:pt idx="7">
                  <c:v>ENV Clade 1-A Norm</c:v>
                </c:pt>
                <c:pt idx="8">
                  <c:v>ENV Clade 1-B</c:v>
                </c:pt>
                <c:pt idx="9">
                  <c:v>ENV Clade 2 </c:v>
                </c:pt>
                <c:pt idx="10">
                  <c:v>ENV Clade 3-A </c:v>
                </c:pt>
                <c:pt idx="11">
                  <c:v>ENV Clade 3-B</c:v>
                </c:pt>
                <c:pt idx="12">
                  <c:v>MSRV </c:v>
                </c:pt>
              </c:strCache>
            </c:strRef>
          </c:cat>
          <c:val>
            <c:numRef>
              <c:f>'HERV expression in MS types '!$C$5:$O$5</c:f>
              <c:numCache>
                <c:formatCode>General</c:formatCode>
                <c:ptCount val="13"/>
                <c:pt idx="0">
                  <c:v>0.13096006716216213</c:v>
                </c:pt>
                <c:pt idx="1">
                  <c:v>0.1107589867933057</c:v>
                </c:pt>
                <c:pt idx="2">
                  <c:v>7.3475026469473209E-3</c:v>
                </c:pt>
                <c:pt idx="3">
                  <c:v>-2.7231163611409051E-2</c:v>
                </c:pt>
                <c:pt idx="4">
                  <c:v>-0.42692274713920675</c:v>
                </c:pt>
                <c:pt idx="5">
                  <c:v>0.30452025607739375</c:v>
                </c:pt>
                <c:pt idx="6">
                  <c:v>0.13313812089676513</c:v>
                </c:pt>
                <c:pt idx="7">
                  <c:v>-0.1784469584191718</c:v>
                </c:pt>
                <c:pt idx="8">
                  <c:v>2.3747202500005143E-2</c:v>
                </c:pt>
                <c:pt idx="9">
                  <c:v>0.41539208418744483</c:v>
                </c:pt>
                <c:pt idx="10">
                  <c:v>0.25133533866769636</c:v>
                </c:pt>
                <c:pt idx="11">
                  <c:v>0.34420120858132097</c:v>
                </c:pt>
                <c:pt idx="12">
                  <c:v>0.16297965249172747</c:v>
                </c:pt>
              </c:numCache>
            </c:numRef>
          </c:val>
        </c:ser>
        <c:ser>
          <c:idx val="4"/>
          <c:order val="4"/>
          <c:tx>
            <c:strRef>
              <c:f>'HERV expression in MS types '!$A$6</c:f>
              <c:strCache>
                <c:ptCount val="1"/>
                <c:pt idx="0">
                  <c:v>Relapsing Remitting MS</c:v>
                </c:pt>
              </c:strCache>
            </c:strRef>
          </c:tx>
          <c:invertIfNegative val="0"/>
          <c:cat>
            <c:strRef>
              <c:f>'HERV expression in MS types '!$C$1:$O$1</c:f>
              <c:strCache>
                <c:ptCount val="13"/>
                <c:pt idx="0">
                  <c:v>GAG Clade 1-A </c:v>
                </c:pt>
                <c:pt idx="1">
                  <c:v>GAG Clade 1-B </c:v>
                </c:pt>
                <c:pt idx="2">
                  <c:v>GAG Clade 1-C </c:v>
                </c:pt>
                <c:pt idx="3">
                  <c:v>GAG Clade 2 </c:v>
                </c:pt>
                <c:pt idx="4">
                  <c:v>GAG Clade 3-AExpression</c:v>
                </c:pt>
                <c:pt idx="5">
                  <c:v>GAG Clade 3-B Norm</c:v>
                </c:pt>
                <c:pt idx="6">
                  <c:v>GAG Clade 3-C </c:v>
                </c:pt>
                <c:pt idx="7">
                  <c:v>ENV Clade 1-A Norm</c:v>
                </c:pt>
                <c:pt idx="8">
                  <c:v>ENV Clade 1-B</c:v>
                </c:pt>
                <c:pt idx="9">
                  <c:v>ENV Clade 2 </c:v>
                </c:pt>
                <c:pt idx="10">
                  <c:v>ENV Clade 3-A </c:v>
                </c:pt>
                <c:pt idx="11">
                  <c:v>ENV Clade 3-B</c:v>
                </c:pt>
                <c:pt idx="12">
                  <c:v>MSRV </c:v>
                </c:pt>
              </c:strCache>
            </c:strRef>
          </c:cat>
          <c:val>
            <c:numRef>
              <c:f>'HERV expression in MS types '!$C$6:$O$6</c:f>
              <c:numCache>
                <c:formatCode>General</c:formatCode>
                <c:ptCount val="13"/>
                <c:pt idx="0">
                  <c:v>0.11120320869438688</c:v>
                </c:pt>
                <c:pt idx="1">
                  <c:v>0.10578311705885637</c:v>
                </c:pt>
                <c:pt idx="2">
                  <c:v>-6.7290661523350781E-2</c:v>
                </c:pt>
                <c:pt idx="3">
                  <c:v>0.17613148844730281</c:v>
                </c:pt>
                <c:pt idx="4">
                  <c:v>-0.29155018043854686</c:v>
                </c:pt>
                <c:pt idx="5">
                  <c:v>0.41907262965197478</c:v>
                </c:pt>
                <c:pt idx="6">
                  <c:v>0.13868496136004363</c:v>
                </c:pt>
                <c:pt idx="7">
                  <c:v>-0.32028101508876561</c:v>
                </c:pt>
                <c:pt idx="8">
                  <c:v>0.15808500730337077</c:v>
                </c:pt>
                <c:pt idx="9">
                  <c:v>0.41648456401207734</c:v>
                </c:pt>
                <c:pt idx="10">
                  <c:v>0.39898549150560791</c:v>
                </c:pt>
                <c:pt idx="11">
                  <c:v>0.46583864452404661</c:v>
                </c:pt>
                <c:pt idx="12">
                  <c:v>7.1820410852185823E-3</c:v>
                </c:pt>
              </c:numCache>
            </c:numRef>
          </c:val>
        </c:ser>
        <c:ser>
          <c:idx val="5"/>
          <c:order val="5"/>
          <c:tx>
            <c:strRef>
              <c:f>'HERV expression in MS types '!$A$7</c:f>
              <c:strCache>
                <c:ptCount val="1"/>
                <c:pt idx="0">
                  <c:v>Not Specificied MS type </c:v>
                </c:pt>
              </c:strCache>
            </c:strRef>
          </c:tx>
          <c:invertIfNegative val="0"/>
          <c:cat>
            <c:strRef>
              <c:f>'HERV expression in MS types '!$C$1:$O$1</c:f>
              <c:strCache>
                <c:ptCount val="13"/>
                <c:pt idx="0">
                  <c:v>GAG Clade 1-A </c:v>
                </c:pt>
                <c:pt idx="1">
                  <c:v>GAG Clade 1-B </c:v>
                </c:pt>
                <c:pt idx="2">
                  <c:v>GAG Clade 1-C </c:v>
                </c:pt>
                <c:pt idx="3">
                  <c:v>GAG Clade 2 </c:v>
                </c:pt>
                <c:pt idx="4">
                  <c:v>GAG Clade 3-AExpression</c:v>
                </c:pt>
                <c:pt idx="5">
                  <c:v>GAG Clade 3-B Norm</c:v>
                </c:pt>
                <c:pt idx="6">
                  <c:v>GAG Clade 3-C </c:v>
                </c:pt>
                <c:pt idx="7">
                  <c:v>ENV Clade 1-A Norm</c:v>
                </c:pt>
                <c:pt idx="8">
                  <c:v>ENV Clade 1-B</c:v>
                </c:pt>
                <c:pt idx="9">
                  <c:v>ENV Clade 2 </c:v>
                </c:pt>
                <c:pt idx="10">
                  <c:v>ENV Clade 3-A </c:v>
                </c:pt>
                <c:pt idx="11">
                  <c:v>ENV Clade 3-B</c:v>
                </c:pt>
                <c:pt idx="12">
                  <c:v>MSRV </c:v>
                </c:pt>
              </c:strCache>
            </c:strRef>
          </c:cat>
          <c:val>
            <c:numRef>
              <c:f>'HERV expression in MS types '!$C$7:$O$7</c:f>
              <c:numCache>
                <c:formatCode>General</c:formatCode>
                <c:ptCount val="13"/>
                <c:pt idx="0">
                  <c:v>0.11477443607461182</c:v>
                </c:pt>
                <c:pt idx="1">
                  <c:v>0.18481491033541306</c:v>
                </c:pt>
                <c:pt idx="2">
                  <c:v>1.4784146260137049E-2</c:v>
                </c:pt>
                <c:pt idx="3">
                  <c:v>0.16572218681654208</c:v>
                </c:pt>
                <c:pt idx="4">
                  <c:v>-0.38125134487320822</c:v>
                </c:pt>
                <c:pt idx="5">
                  <c:v>0.35429059035490584</c:v>
                </c:pt>
                <c:pt idx="6">
                  <c:v>0.28090478351766396</c:v>
                </c:pt>
                <c:pt idx="7">
                  <c:v>-0.5340544011921794</c:v>
                </c:pt>
                <c:pt idx="8">
                  <c:v>0.10593545417885558</c:v>
                </c:pt>
                <c:pt idx="9">
                  <c:v>0.3030492981817075</c:v>
                </c:pt>
                <c:pt idx="10">
                  <c:v>0.32537640994257833</c:v>
                </c:pt>
                <c:pt idx="11">
                  <c:v>0.37619882731520204</c:v>
                </c:pt>
                <c:pt idx="12">
                  <c:v>0.212466247307635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5795328"/>
        <c:axId val="165796864"/>
      </c:barChart>
      <c:catAx>
        <c:axId val="165795328"/>
        <c:scaling>
          <c:orientation val="minMax"/>
        </c:scaling>
        <c:delete val="0"/>
        <c:axPos val="b"/>
        <c:majorTickMark val="out"/>
        <c:minorTickMark val="none"/>
        <c:tickLblPos val="low"/>
        <c:crossAx val="165796864"/>
        <c:crosses val="autoZero"/>
        <c:auto val="1"/>
        <c:lblAlgn val="ctr"/>
        <c:lblOffset val="100"/>
        <c:noMultiLvlLbl val="0"/>
      </c:catAx>
      <c:valAx>
        <c:axId val="165796864"/>
        <c:scaling>
          <c:orientation val="minMax"/>
          <c:max val="0.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</a:t>
                </a:r>
                <a:r>
                  <a:rPr lang="en-US" baseline="0"/>
                  <a:t> log2 RNA level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7953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RPL13 -</a:t>
            </a:r>
            <a:r>
              <a:rPr lang="en-US" sz="1400" baseline="0"/>
              <a:t> </a:t>
            </a:r>
            <a:r>
              <a:rPr lang="en-US" sz="1400" b="1" i="0" u="none" strike="noStrike" baseline="0">
                <a:effectLst/>
              </a:rPr>
              <a:t>Standard Curve  </a:t>
            </a:r>
            <a:endParaRPr lang="en-US" sz="1400"/>
          </a:p>
        </c:rich>
      </c:tx>
      <c:layout>
        <c:manualLayout>
          <c:xMode val="edge"/>
          <c:yMode val="edge"/>
          <c:x val="0.22848423149122299"/>
          <c:y val="5.005005005005010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4172559931464503E-2"/>
          <c:y val="4.9992572130990003E-2"/>
          <c:w val="0.76618898165396798"/>
          <c:h val="0.79221403852583805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10</c:f>
              <c:strCache>
                <c:ptCount val="1"/>
                <c:pt idx="0">
                  <c:v>Ct-Pool-RPl13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10:$I$10</c:f>
              <c:numCache>
                <c:formatCode>General</c:formatCode>
                <c:ptCount val="8"/>
                <c:pt idx="0">
                  <c:v>19.07</c:v>
                </c:pt>
                <c:pt idx="4">
                  <c:v>24</c:v>
                </c:pt>
                <c:pt idx="5">
                  <c:v>25.45</c:v>
                </c:pt>
                <c:pt idx="6">
                  <c:v>26.6</c:v>
                </c:pt>
                <c:pt idx="7">
                  <c:v>27.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11</c:f>
              <c:strCache>
                <c:ptCount val="1"/>
                <c:pt idx="0">
                  <c:v>Ct-Pool-RPl13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1.23142156277784E-2"/>
                  <c:y val="7.02478703591565E-2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11:$I$11</c:f>
              <c:numCache>
                <c:formatCode>General</c:formatCode>
                <c:ptCount val="8"/>
                <c:pt idx="0">
                  <c:v>18.84</c:v>
                </c:pt>
                <c:pt idx="4">
                  <c:v>23.99</c:v>
                </c:pt>
                <c:pt idx="5">
                  <c:v>25.43</c:v>
                </c:pt>
                <c:pt idx="6">
                  <c:v>26.82</c:v>
                </c:pt>
                <c:pt idx="7">
                  <c:v>27.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4977280"/>
        <c:axId val="144983552"/>
      </c:scatterChart>
      <c:valAx>
        <c:axId val="1449772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of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4983552"/>
        <c:crosses val="autoZero"/>
        <c:crossBetween val="midCat"/>
      </c:valAx>
      <c:valAx>
        <c:axId val="144983552"/>
        <c:scaling>
          <c:orientation val="minMax"/>
          <c:max val="35"/>
          <c:min val="1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</a:t>
                </a:r>
                <a:r>
                  <a:rPr lang="en-US" baseline="0"/>
                  <a:t> Value 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81547016351141"/>
              <c:y val="0.36988784128668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44977280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475624574705897"/>
          <c:y val="6.8510520930646399E-2"/>
          <c:w val="0.16361937396714299"/>
          <c:h val="0.82774998887850904"/>
        </c:manualLayout>
      </c:layout>
      <c:overlay val="1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UBC -</a:t>
            </a:r>
            <a:r>
              <a:rPr lang="en-US" sz="1400" baseline="0" dirty="0"/>
              <a:t> </a:t>
            </a:r>
            <a:r>
              <a:rPr lang="en-US" sz="1400" b="1" i="0" u="none" strike="noStrike" baseline="0" dirty="0">
                <a:effectLst/>
              </a:rPr>
              <a:t>Standard Curve  </a:t>
            </a:r>
            <a:endParaRPr lang="en-US" sz="1400" dirty="0"/>
          </a:p>
        </c:rich>
      </c:tx>
      <c:layout>
        <c:manualLayout>
          <c:xMode val="edge"/>
          <c:yMode val="edge"/>
          <c:x val="0.24652590020552101"/>
          <c:y val="5.005005005005010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4172559931464503E-2"/>
          <c:y val="4.9992572130990003E-2"/>
          <c:w val="0.76618898165396798"/>
          <c:h val="0.79221403852583805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15</c:f>
              <c:strCache>
                <c:ptCount val="1"/>
                <c:pt idx="0">
                  <c:v>Ct-Pool-UBC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15:$I$15</c:f>
              <c:numCache>
                <c:formatCode>General</c:formatCode>
                <c:ptCount val="8"/>
                <c:pt idx="0">
                  <c:v>17.79</c:v>
                </c:pt>
                <c:pt idx="4">
                  <c:v>22.57</c:v>
                </c:pt>
                <c:pt idx="5">
                  <c:v>24.12</c:v>
                </c:pt>
                <c:pt idx="6">
                  <c:v>25.41</c:v>
                </c:pt>
                <c:pt idx="7">
                  <c:v>26.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16</c:f>
              <c:strCache>
                <c:ptCount val="1"/>
                <c:pt idx="0">
                  <c:v>Ct-Pool-UBC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1.23142156277784E-2"/>
                  <c:y val="7.02478703591565E-2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16:$I$16</c:f>
              <c:numCache>
                <c:formatCode>General</c:formatCode>
                <c:ptCount val="8"/>
                <c:pt idx="0">
                  <c:v>17.420000000000002</c:v>
                </c:pt>
                <c:pt idx="4">
                  <c:v>22.95</c:v>
                </c:pt>
                <c:pt idx="5">
                  <c:v>24.12</c:v>
                </c:pt>
                <c:pt idx="6">
                  <c:v>25.51</c:v>
                </c:pt>
                <c:pt idx="7">
                  <c:v>26.5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5014144"/>
        <c:axId val="145020416"/>
      </c:scatterChart>
      <c:valAx>
        <c:axId val="1450141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of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5020416"/>
        <c:crosses val="autoZero"/>
        <c:crossBetween val="midCat"/>
      </c:valAx>
      <c:valAx>
        <c:axId val="145020416"/>
        <c:scaling>
          <c:orientation val="minMax"/>
          <c:max val="35"/>
          <c:min val="1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</a:t>
                </a:r>
                <a:r>
                  <a:rPr lang="en-US" baseline="0"/>
                  <a:t> Value 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81547016351141"/>
              <c:y val="0.36988784128668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45014144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3092907875778199"/>
          <c:y val="5.9868924042152397E-2"/>
          <c:w val="0.145100855448624"/>
          <c:h val="0.82103822983088104"/>
        </c:manualLayout>
      </c:layout>
      <c:overlay val="1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GAG-Clade 1-A -Standard Curve 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20</c:f>
              <c:strCache>
                <c:ptCount val="1"/>
                <c:pt idx="0">
                  <c:v>Ct-Pool-Clade 1-A 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20:$I$20</c:f>
              <c:numCache>
                <c:formatCode>General</c:formatCode>
                <c:ptCount val="8"/>
                <c:pt idx="3">
                  <c:v>28.08</c:v>
                </c:pt>
                <c:pt idx="4">
                  <c:v>29.04</c:v>
                </c:pt>
                <c:pt idx="5">
                  <c:v>30.68</c:v>
                </c:pt>
                <c:pt idx="6">
                  <c:v>31.5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21</c:f>
              <c:strCache>
                <c:ptCount val="1"/>
                <c:pt idx="0">
                  <c:v>Ct-Pool-Clade 1-A 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5.1706239031320501E-3"/>
                  <c:y val="6.2538838112196099E-2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21:$I$21</c:f>
              <c:numCache>
                <c:formatCode>General</c:formatCode>
                <c:ptCount val="8"/>
                <c:pt idx="3">
                  <c:v>27.95</c:v>
                </c:pt>
                <c:pt idx="4">
                  <c:v>29.43</c:v>
                </c:pt>
                <c:pt idx="5">
                  <c:v>30.64</c:v>
                </c:pt>
                <c:pt idx="6">
                  <c:v>31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734464"/>
        <c:axId val="164736384"/>
      </c:scatterChart>
      <c:valAx>
        <c:axId val="1647344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4736384"/>
        <c:crosses val="autoZero"/>
        <c:crossBetween val="midCat"/>
      </c:valAx>
      <c:valAx>
        <c:axId val="164736384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4734464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5.74143697503278E-2"/>
          <c:w val="0.16629491525613099"/>
          <c:h val="0.81353597692180402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GAG Clade 1-B - Standard Curve</a:t>
            </a:r>
            <a:endParaRPr lang="en-US" sz="1400" b="1"/>
          </a:p>
        </c:rich>
      </c:tx>
      <c:layout>
        <c:manualLayout>
          <c:xMode val="edge"/>
          <c:yMode val="edge"/>
          <c:x val="0.221425180474767"/>
          <c:y val="4.15837827070158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884545107246301E-2"/>
          <c:y val="5.3607607762119397E-2"/>
          <c:w val="0.77160530327475996"/>
          <c:h val="0.79092375049800501"/>
        </c:manualLayout>
      </c:layout>
      <c:scatterChart>
        <c:scatterStyle val="lineMarker"/>
        <c:varyColors val="0"/>
        <c:ser>
          <c:idx val="1"/>
          <c:order val="0"/>
          <c:tx>
            <c:strRef>
              <c:f>'Pool graphs '!$A$25</c:f>
              <c:strCache>
                <c:ptCount val="1"/>
                <c:pt idx="0">
                  <c:v>Ct-Pool-GAG Clade 1-B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25:$I$25</c:f>
              <c:numCache>
                <c:formatCode>General</c:formatCode>
                <c:ptCount val="8"/>
                <c:pt idx="0">
                  <c:v>20.51</c:v>
                </c:pt>
                <c:pt idx="4">
                  <c:v>25.5</c:v>
                </c:pt>
                <c:pt idx="5">
                  <c:v>26.71</c:v>
                </c:pt>
                <c:pt idx="6">
                  <c:v>28.19</c:v>
                </c:pt>
                <c:pt idx="7">
                  <c:v>28.96</c:v>
                </c:pt>
              </c:numCache>
            </c:numRef>
          </c:yVal>
          <c:smooth val="0"/>
        </c:ser>
        <c:ser>
          <c:idx val="2"/>
          <c:order val="1"/>
          <c:tx>
            <c:strRef>
              <c:f>'Pool graphs '!$A$26</c:f>
              <c:strCache>
                <c:ptCount val="1"/>
                <c:pt idx="0">
                  <c:v>Ct-Pool-GAG Clade 1-B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  <c:spPr>
              <a:solidFill>
                <a:schemeClr val="accent1"/>
              </a:solidFill>
            </c:spPr>
          </c:marker>
          <c:trendline>
            <c:trendlineType val="linear"/>
            <c:dispRSqr val="1"/>
            <c:dispEq val="1"/>
            <c:trendlineLbl>
              <c:layout/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26:$I$26</c:f>
              <c:numCache>
                <c:formatCode>General</c:formatCode>
                <c:ptCount val="8"/>
                <c:pt idx="0">
                  <c:v>20.47</c:v>
                </c:pt>
                <c:pt idx="4">
                  <c:v>25.59</c:v>
                </c:pt>
                <c:pt idx="5">
                  <c:v>26.69</c:v>
                </c:pt>
                <c:pt idx="6">
                  <c:v>27.94</c:v>
                </c:pt>
                <c:pt idx="7">
                  <c:v>28.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779520"/>
        <c:axId val="164781440"/>
      </c:scatterChart>
      <c:valAx>
        <c:axId val="1647795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of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4781440"/>
        <c:crosses val="autoZero"/>
        <c:crossBetween val="midCat"/>
      </c:valAx>
      <c:valAx>
        <c:axId val="164781440"/>
        <c:scaling>
          <c:orientation val="minMax"/>
          <c:max val="35"/>
          <c:min val="1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</a:t>
                </a:r>
                <a:r>
                  <a:rPr lang="en-US" baseline="0"/>
                  <a:t> Value 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82496110995665795"/>
              <c:y val="0.3761910039223170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4779520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4376986855569003"/>
          <c:y val="6.69567205000276E-2"/>
          <c:w val="0.145994170670178"/>
          <c:h val="0.78267013732892998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GAG-Clade 1-C - Standard Curve</a:t>
            </a:r>
            <a:endParaRPr lang="en-US" sz="1400"/>
          </a:p>
        </c:rich>
      </c:tx>
      <c:layout>
        <c:manualLayout>
          <c:xMode val="edge"/>
          <c:yMode val="edge"/>
          <c:x val="0.127792650390362"/>
          <c:y val="3.8298478420612903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566333753009003E-2"/>
          <c:y val="5.3607607762119397E-2"/>
          <c:w val="0.76989586060469395"/>
          <c:h val="0.77758070790678502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30</c:f>
              <c:strCache>
                <c:ptCount val="1"/>
                <c:pt idx="0">
                  <c:v>Ct-Pool-GAG Clade 1-C 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30:$I$30</c:f>
              <c:numCache>
                <c:formatCode>General</c:formatCode>
                <c:ptCount val="8"/>
                <c:pt idx="0">
                  <c:v>24.02</c:v>
                </c:pt>
                <c:pt idx="4">
                  <c:v>28.89</c:v>
                </c:pt>
                <c:pt idx="5">
                  <c:v>30.25</c:v>
                </c:pt>
                <c:pt idx="6">
                  <c:v>31.64</c:v>
                </c:pt>
                <c:pt idx="7">
                  <c:v>31.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31</c:f>
              <c:strCache>
                <c:ptCount val="1"/>
                <c:pt idx="0">
                  <c:v>Ct-Pool-GAG Clade 1-C 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/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31:$I$31</c:f>
              <c:numCache>
                <c:formatCode>General</c:formatCode>
                <c:ptCount val="8"/>
                <c:pt idx="0">
                  <c:v>23.93</c:v>
                </c:pt>
                <c:pt idx="4">
                  <c:v>28.81</c:v>
                </c:pt>
                <c:pt idx="5">
                  <c:v>30.18</c:v>
                </c:pt>
                <c:pt idx="6">
                  <c:v>31.18</c:v>
                </c:pt>
                <c:pt idx="7">
                  <c:v>32.2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804096"/>
        <c:axId val="164806016"/>
      </c:scatterChart>
      <c:valAx>
        <c:axId val="1648040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of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4806016"/>
        <c:crosses val="autoZero"/>
        <c:crossBetween val="midCat"/>
      </c:valAx>
      <c:valAx>
        <c:axId val="164806016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</a:t>
                </a:r>
                <a:r>
                  <a:rPr lang="en-US" baseline="0"/>
                  <a:t> Value 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82104961886933503"/>
              <c:y val="0.3912708125034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4804096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3014204816305204"/>
          <c:y val="7.6701065775868896E-2"/>
          <c:w val="0.149495798255743"/>
          <c:h val="0.779353575121291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GAG Clade 2 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35</c:f>
              <c:strCache>
                <c:ptCount val="1"/>
                <c:pt idx="0">
                  <c:v>Ct-Pool-GAG Clade 2 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35:$I$35</c:f>
              <c:numCache>
                <c:formatCode>General</c:formatCode>
                <c:ptCount val="8"/>
                <c:pt idx="0">
                  <c:v>23.61</c:v>
                </c:pt>
                <c:pt idx="4">
                  <c:v>27.26</c:v>
                </c:pt>
                <c:pt idx="5">
                  <c:v>28.88</c:v>
                </c:pt>
                <c:pt idx="6">
                  <c:v>29.67</c:v>
                </c:pt>
                <c:pt idx="7">
                  <c:v>30.2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36</c:f>
              <c:strCache>
                <c:ptCount val="1"/>
                <c:pt idx="0">
                  <c:v>Ct-Pool-GAG Clade 2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5.1706239031320501E-3"/>
                  <c:y val="6.2538838112196099E-2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36:$I$36</c:f>
              <c:numCache>
                <c:formatCode>General</c:formatCode>
                <c:ptCount val="8"/>
                <c:pt idx="0">
                  <c:v>23.83</c:v>
                </c:pt>
                <c:pt idx="4">
                  <c:v>27.94</c:v>
                </c:pt>
                <c:pt idx="5">
                  <c:v>28.88</c:v>
                </c:pt>
                <c:pt idx="6">
                  <c:v>30.39</c:v>
                </c:pt>
                <c:pt idx="7">
                  <c:v>30.6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926976"/>
        <c:axId val="164928896"/>
      </c:scatterChart>
      <c:valAx>
        <c:axId val="1649269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4928896"/>
        <c:crosses val="autoZero"/>
        <c:crossBetween val="midCat"/>
      </c:valAx>
      <c:valAx>
        <c:axId val="164928896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4926976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6.9926882262840301E-2"/>
          <c:w val="0.16629491525613099"/>
          <c:h val="0.83021932693848699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GAG Clade 3-A 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40</c:f>
              <c:strCache>
                <c:ptCount val="1"/>
                <c:pt idx="0">
                  <c:v>Ct-Pool-GAG Clade 3-A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40:$I$40</c:f>
              <c:numCache>
                <c:formatCode>General</c:formatCode>
                <c:ptCount val="8"/>
                <c:pt idx="0">
                  <c:v>20.22</c:v>
                </c:pt>
                <c:pt idx="3">
                  <c:v>24.47</c:v>
                </c:pt>
                <c:pt idx="4">
                  <c:v>25.1</c:v>
                </c:pt>
                <c:pt idx="5">
                  <c:v>26.69</c:v>
                </c:pt>
                <c:pt idx="6">
                  <c:v>28.1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41</c:f>
              <c:strCache>
                <c:ptCount val="1"/>
                <c:pt idx="0">
                  <c:v>Ct-Pool-GAG Clade 3-A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0.31802562836669002"/>
                  <c:y val="-7.2183638409525394E-2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41:$I$41</c:f>
              <c:numCache>
                <c:formatCode>General</c:formatCode>
                <c:ptCount val="8"/>
                <c:pt idx="0">
                  <c:v>20.29</c:v>
                </c:pt>
                <c:pt idx="3">
                  <c:v>24.03</c:v>
                </c:pt>
                <c:pt idx="4">
                  <c:v>25.2</c:v>
                </c:pt>
                <c:pt idx="5">
                  <c:v>26.72</c:v>
                </c:pt>
                <c:pt idx="6">
                  <c:v>28.0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222272"/>
        <c:axId val="165232640"/>
      </c:scatterChart>
      <c:valAx>
        <c:axId val="1652222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232640"/>
        <c:crosses val="autoZero"/>
        <c:crossBetween val="midCat"/>
      </c:valAx>
      <c:valAx>
        <c:axId val="165232640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5222272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5.74143697503278E-2"/>
          <c:w val="0.16629491525613099"/>
          <c:h val="0.80519430191346197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b="1" i="0" u="none" strike="noStrike" baseline="0">
                <a:effectLst/>
              </a:rPr>
              <a:t>GAG Clade 3-B - Standard Curve</a:t>
            </a:r>
            <a:endParaRPr lang="en-US" sz="1400" b="1"/>
          </a:p>
        </c:rich>
      </c:tx>
      <c:layout>
        <c:manualLayout>
          <c:xMode val="edge"/>
          <c:yMode val="edge"/>
          <c:x val="0.139300913210431"/>
          <c:y val="5.441366168499740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4.5948713900596003E-2"/>
          <c:y val="5.3058616521842503E-2"/>
          <c:w val="0.77308733850819999"/>
          <c:h val="0.81288335247430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ool graphs '!$A$45</c:f>
              <c:strCache>
                <c:ptCount val="1"/>
                <c:pt idx="0">
                  <c:v>Ct-Pool-GAG Clade 3-B-1</c:v>
                </c:pt>
              </c:strCache>
            </c:strRef>
          </c:tx>
          <c:spPr>
            <a:ln w="28575">
              <a:noFill/>
            </a:ln>
          </c:spPr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45:$I$45</c:f>
              <c:numCache>
                <c:formatCode>General</c:formatCode>
                <c:ptCount val="8"/>
                <c:pt idx="4">
                  <c:v>25.04</c:v>
                </c:pt>
                <c:pt idx="5">
                  <c:v>25.56</c:v>
                </c:pt>
                <c:pt idx="6">
                  <c:v>27.91</c:v>
                </c:pt>
                <c:pt idx="7">
                  <c:v>27.8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ool graphs '!$A$46</c:f>
              <c:strCache>
                <c:ptCount val="1"/>
                <c:pt idx="0">
                  <c:v>Ct-Pool-GAG Clade 3-B-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7"/>
          </c:marker>
          <c:trendline>
            <c:trendlineType val="linear"/>
            <c:dispRSqr val="1"/>
            <c:dispEq val="1"/>
            <c:trendlineLbl>
              <c:layout>
                <c:manualLayout>
                  <c:x val="-1.8988393156611601E-2"/>
                  <c:y val="-0.36122488546714798"/>
                </c:manualLayout>
              </c:layout>
              <c:numFmt formatCode="General" sourceLinked="0"/>
            </c:trendlineLbl>
          </c:trendline>
          <c:xVal>
            <c:numRef>
              <c:f>'Pool graphs '!$B$2:$I$2</c:f>
              <c:numCache>
                <c:formatCode>General</c:formatCode>
                <c:ptCount val="8"/>
                <c:pt idx="0">
                  <c:v>-2.3219280948873622</c:v>
                </c:pt>
                <c:pt idx="1">
                  <c:v>-3.3219280948873622</c:v>
                </c:pt>
                <c:pt idx="2">
                  <c:v>-4.3219280948873626</c:v>
                </c:pt>
                <c:pt idx="3">
                  <c:v>-5.3219280948873626</c:v>
                </c:pt>
                <c:pt idx="4">
                  <c:v>-6.3219280948873617</c:v>
                </c:pt>
                <c:pt idx="5">
                  <c:v>-7.3219280948873617</c:v>
                </c:pt>
                <c:pt idx="6">
                  <c:v>-8.3219280948873617</c:v>
                </c:pt>
                <c:pt idx="7">
                  <c:v>-9.3219280948873617</c:v>
                </c:pt>
              </c:numCache>
            </c:numRef>
          </c:xVal>
          <c:yVal>
            <c:numRef>
              <c:f>'Pool graphs '!$B$46:$I$46</c:f>
              <c:numCache>
                <c:formatCode>General</c:formatCode>
                <c:ptCount val="8"/>
                <c:pt idx="4">
                  <c:v>24.94</c:v>
                </c:pt>
                <c:pt idx="5">
                  <c:v>26.71</c:v>
                </c:pt>
                <c:pt idx="6">
                  <c:v>27.67</c:v>
                </c:pt>
                <c:pt idx="7">
                  <c:v>28.8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271424"/>
        <c:axId val="165273600"/>
      </c:scatterChart>
      <c:valAx>
        <c:axId val="1652714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og 2 Dilution Poo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273600"/>
        <c:crosses val="autoZero"/>
        <c:crossBetween val="midCat"/>
      </c:valAx>
      <c:valAx>
        <c:axId val="165273600"/>
        <c:scaling>
          <c:orientation val="minMax"/>
          <c:max val="35"/>
          <c:min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t Value </a:t>
                </a:r>
              </a:p>
            </c:rich>
          </c:tx>
          <c:layout>
            <c:manualLayout>
              <c:xMode val="edge"/>
              <c:yMode val="edge"/>
              <c:x val="0.81992220574125296"/>
              <c:y val="0.386924943526384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5271424"/>
        <c:crosses val="autoZero"/>
        <c:crossBetween val="midCat"/>
        <c:majorUnit val="5"/>
        <c:minorUnit val="1"/>
      </c:valAx>
    </c:plotArea>
    <c:legend>
      <c:legendPos val="r"/>
      <c:layout>
        <c:manualLayout>
          <c:xMode val="edge"/>
          <c:yMode val="edge"/>
          <c:x val="0.82159513318048005"/>
          <c:y val="4.9072694741986098E-2"/>
          <c:w val="0.16629491525613099"/>
          <c:h val="0.81353597692180402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763</cdr:x>
      <cdr:y>0.09091</cdr:y>
    </cdr:from>
    <cdr:to>
      <cdr:x>0.51695</cdr:x>
      <cdr:y>0.1538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114800" y="533400"/>
          <a:ext cx="533381" cy="36935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b="1" dirty="0" smtClean="0">
              <a:latin typeface="Arial"/>
              <a:cs typeface="Arial"/>
            </a:rPr>
            <a:t>**</a:t>
          </a:r>
          <a:endParaRPr lang="en-US" b="1" dirty="0">
            <a:latin typeface="Arial"/>
            <a:cs typeface="Arial"/>
          </a:endParaRPr>
        </a:p>
      </cdr:txBody>
    </cdr:sp>
  </cdr:relSizeAnchor>
  <cdr:relSizeAnchor xmlns:cdr="http://schemas.openxmlformats.org/drawingml/2006/chartDrawing">
    <cdr:from>
      <cdr:x>0.40678</cdr:x>
      <cdr:y>0.7013</cdr:y>
    </cdr:from>
    <cdr:to>
      <cdr:x>0.44915</cdr:x>
      <cdr:y>0.74589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3657600" y="4114800"/>
          <a:ext cx="381000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b="1" dirty="0" smtClean="0">
              <a:latin typeface="Arial"/>
              <a:cs typeface="Arial"/>
            </a:rPr>
            <a:t>**</a:t>
          </a:r>
          <a:endParaRPr lang="en-US" b="1" dirty="0">
            <a:latin typeface="Arial"/>
            <a:cs typeface="Arial"/>
          </a:endParaRPr>
        </a:p>
      </cdr:txBody>
    </cdr:sp>
  </cdr:relSizeAnchor>
  <cdr:relSizeAnchor xmlns:cdr="http://schemas.openxmlformats.org/drawingml/2006/chartDrawing">
    <cdr:from>
      <cdr:x>0.72881</cdr:x>
      <cdr:y>0.05195</cdr:y>
    </cdr:from>
    <cdr:to>
      <cdr:x>0.77966</cdr:x>
      <cdr:y>0.11489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6553200" y="304800"/>
          <a:ext cx="457223" cy="36929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b="1" dirty="0" smtClean="0">
              <a:latin typeface="Arial"/>
              <a:cs typeface="Arial"/>
            </a:rPr>
            <a:t>**</a:t>
          </a:r>
          <a:endParaRPr lang="en-US" b="1" dirty="0">
            <a:latin typeface="Arial"/>
            <a:cs typeface="Arial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C9BD3E-4283-0E44-9E11-1C8811AE5373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73FDE3-AECB-FA44-A9EB-5D585E3BF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0166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73FDE3-AECB-FA44-A9EB-5D585E3BFCF0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7117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133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886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77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111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072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165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818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149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412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463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754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A1E812-DBB3-40F4-BBC8-3EE85E49FEC7}" type="datetimeFigureOut">
              <a:rPr lang="en-US" smtClean="0"/>
              <a:t>1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8EFEFC-893E-4FF4-B1DF-A9A186DBE7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51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0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6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STD Curve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023132"/>
              </p:ext>
            </p:extLst>
          </p:nvPr>
        </p:nvGraphicFramePr>
        <p:xfrm>
          <a:off x="228600" y="152399"/>
          <a:ext cx="4158368" cy="3124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0367646"/>
              </p:ext>
            </p:extLst>
          </p:nvPr>
        </p:nvGraphicFramePr>
        <p:xfrm>
          <a:off x="4572000" y="152400"/>
          <a:ext cx="4052888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0454125"/>
              </p:ext>
            </p:extLst>
          </p:nvPr>
        </p:nvGraphicFramePr>
        <p:xfrm>
          <a:off x="228600" y="3352799"/>
          <a:ext cx="4191000" cy="31394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2008770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4998778"/>
              </p:ext>
            </p:extLst>
          </p:nvPr>
        </p:nvGraphicFramePr>
        <p:xfrm>
          <a:off x="152400" y="152400"/>
          <a:ext cx="4104513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9122842"/>
              </p:ext>
            </p:extLst>
          </p:nvPr>
        </p:nvGraphicFramePr>
        <p:xfrm>
          <a:off x="4419600" y="152400"/>
          <a:ext cx="4104513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7449189"/>
              </p:ext>
            </p:extLst>
          </p:nvPr>
        </p:nvGraphicFramePr>
        <p:xfrm>
          <a:off x="152400" y="3352800"/>
          <a:ext cx="4104513" cy="3017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4650922"/>
              </p:ext>
            </p:extLst>
          </p:nvPr>
        </p:nvGraphicFramePr>
        <p:xfrm>
          <a:off x="4419600" y="3352800"/>
          <a:ext cx="4040981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783252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2259663"/>
              </p:ext>
            </p:extLst>
          </p:nvPr>
        </p:nvGraphicFramePr>
        <p:xfrm>
          <a:off x="76200" y="76200"/>
          <a:ext cx="4104513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1974397"/>
              </p:ext>
            </p:extLst>
          </p:nvPr>
        </p:nvGraphicFramePr>
        <p:xfrm>
          <a:off x="4419600" y="76200"/>
          <a:ext cx="4020570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1996645"/>
              </p:ext>
            </p:extLst>
          </p:nvPr>
        </p:nvGraphicFramePr>
        <p:xfrm>
          <a:off x="76200" y="3276600"/>
          <a:ext cx="4101533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07595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5498068"/>
              </p:ext>
            </p:extLst>
          </p:nvPr>
        </p:nvGraphicFramePr>
        <p:xfrm>
          <a:off x="152400" y="152400"/>
          <a:ext cx="4017170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490751"/>
              </p:ext>
            </p:extLst>
          </p:nvPr>
        </p:nvGraphicFramePr>
        <p:xfrm>
          <a:off x="4419600" y="152400"/>
          <a:ext cx="4101533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2928022"/>
              </p:ext>
            </p:extLst>
          </p:nvPr>
        </p:nvGraphicFramePr>
        <p:xfrm>
          <a:off x="152400" y="3352800"/>
          <a:ext cx="3972946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284269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8353151"/>
              </p:ext>
            </p:extLst>
          </p:nvPr>
        </p:nvGraphicFramePr>
        <p:xfrm>
          <a:off x="228600" y="152400"/>
          <a:ext cx="4104513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4950763"/>
              </p:ext>
            </p:extLst>
          </p:nvPr>
        </p:nvGraphicFramePr>
        <p:xfrm>
          <a:off x="4572000" y="152400"/>
          <a:ext cx="3969545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8710096"/>
              </p:ext>
            </p:extLst>
          </p:nvPr>
        </p:nvGraphicFramePr>
        <p:xfrm>
          <a:off x="2438400" y="3352800"/>
          <a:ext cx="4104513" cy="3044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8087572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5465818"/>
              </p:ext>
            </p:extLst>
          </p:nvPr>
        </p:nvGraphicFramePr>
        <p:xfrm>
          <a:off x="1524000" y="1828800"/>
          <a:ext cx="5791200" cy="3453172"/>
        </p:xfrm>
        <a:graphic>
          <a:graphicData uri="http://schemas.openxmlformats.org/drawingml/2006/table">
            <a:tbl>
              <a:tblPr>
                <a:tableStyleId>{69C7853C-536D-4A76-A0AE-DD22124D55A5}</a:tableStyleId>
              </a:tblPr>
              <a:tblGrid>
                <a:gridCol w="1676400"/>
                <a:gridCol w="1295400"/>
                <a:gridCol w="1227510"/>
                <a:gridCol w="1591890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/>
                          <a:cs typeface="Arial"/>
                        </a:rPr>
                        <a:t>Primer Pai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/>
                          <a:cs typeface="Arial"/>
                        </a:rPr>
                        <a:t>Standard Curve</a:t>
                      </a:r>
                      <a:r>
                        <a:rPr lang="en-US" sz="1200" b="1" u="none" strike="noStrike" baseline="0" dirty="0" smtClean="0"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200" b="1" u="none" strike="noStrike" dirty="0" smtClean="0">
                          <a:effectLst/>
                          <a:latin typeface="Arial"/>
                          <a:cs typeface="Arial"/>
                        </a:rPr>
                        <a:t>Slop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8932" marR="8932" marT="89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/>
                          <a:cs typeface="Arial"/>
                        </a:rPr>
                        <a:t>R-Squar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8932" marR="8932" marT="89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/>
                          <a:cs typeface="Arial"/>
                        </a:rPr>
                        <a:t>PCR</a:t>
                      </a:r>
                      <a:r>
                        <a:rPr lang="en-US" sz="1200" b="1" u="none" strike="noStrike" baseline="0" dirty="0" smtClean="0">
                          <a:effectLst/>
                          <a:latin typeface="Arial"/>
                          <a:cs typeface="Arial"/>
                        </a:rPr>
                        <a:t> Efficiency </a:t>
                      </a:r>
                      <a:r>
                        <a:rPr lang="en-US" sz="1200" b="1" u="none" strike="noStrike" dirty="0" smtClean="0">
                          <a:effectLst/>
                          <a:latin typeface="Arial"/>
                          <a:cs typeface="Arial"/>
                        </a:rPr>
                        <a:t>(</a:t>
                      </a:r>
                      <a:r>
                        <a:rPr lang="en-US" sz="1200" b="1" u="none" strike="noStrike" dirty="0">
                          <a:effectLst/>
                          <a:latin typeface="Arial"/>
                          <a:cs typeface="Arial"/>
                        </a:rPr>
                        <a:t>%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8932" marR="8932" marT="8932" marB="0" anchor="ctr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RPL19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79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RPL-</a:t>
                      </a:r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13**</a:t>
                      </a:r>
                      <a:endParaRPr lang="en-US" sz="1200" b="0" i="0" u="none" strike="noStrike" dirty="0">
                        <a:solidFill>
                          <a:srgbClr val="C0504D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-1.28</a:t>
                      </a:r>
                      <a:endParaRPr lang="en-US" sz="1200" b="0" i="0" u="none" strike="noStrike" dirty="0">
                        <a:solidFill>
                          <a:srgbClr val="C0504D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97</a:t>
                      </a:r>
                      <a:endParaRPr lang="en-US" sz="1200" b="0" i="0" u="none" strike="noStrike" dirty="0">
                        <a:solidFill>
                          <a:srgbClr val="C0504D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71.9</a:t>
                      </a:r>
                      <a:endParaRPr lang="en-US" sz="1200" b="0" i="0" u="none" strike="noStrike" dirty="0">
                        <a:solidFill>
                          <a:srgbClr val="C0504D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UBC**</a:t>
                      </a:r>
                      <a:endParaRPr lang="en-US" sz="1200" b="0" i="0" u="none" strike="noStrike" dirty="0">
                        <a:solidFill>
                          <a:srgbClr val="C0504D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31</a:t>
                      </a:r>
                      <a:endParaRPr lang="en-US" sz="1200" b="0" i="0" u="none" strike="noStrike">
                        <a:solidFill>
                          <a:srgbClr val="C0504D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98</a:t>
                      </a:r>
                      <a:endParaRPr lang="en-US" sz="1200" b="0" i="0" u="none" strike="noStrike" dirty="0">
                        <a:solidFill>
                          <a:srgbClr val="C0504D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69.7</a:t>
                      </a:r>
                      <a:endParaRPr lang="en-US" sz="1200" b="0" i="0" u="none" strike="noStrike" dirty="0">
                        <a:solidFill>
                          <a:srgbClr val="C0504D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GAG-Clade-1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8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79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GAG-Clade-1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9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79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GAG-Clade-1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79.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GAG-Clade-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98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GAG-Clade-3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71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GAG-Clade-3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72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GAG-Clade-3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98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ENV-Clade-1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0.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8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107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ENV-Clade-1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6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85.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ENV-Clade-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0.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6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104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ENV-Clade-3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8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82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ENV-Clade-3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  <a:latin typeface="Arial"/>
                          <a:cs typeface="Arial"/>
                        </a:rPr>
                        <a:t>0.98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83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ENV MSRV HERV-W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-1.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/>
                          <a:cs typeface="Arial"/>
                        </a:rPr>
                        <a:t>0.9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/>
                          <a:cs typeface="Arial"/>
                        </a:rPr>
                        <a:t>90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743200" y="5943600"/>
            <a:ext cx="39036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* Selected as reference gene </a:t>
            </a:r>
            <a:r>
              <a:rPr lang="en-US" sz="1200" dirty="0"/>
              <a:t>for expression determinations </a:t>
            </a:r>
            <a:endParaRPr lang="en-US" sz="1200" dirty="0" smtClean="0"/>
          </a:p>
          <a:p>
            <a:r>
              <a:rPr lang="en-US" sz="1200" dirty="0" smtClean="0"/>
              <a:t>** Not selected as reference gene</a:t>
            </a:r>
            <a:endParaRPr lang="en-US" sz="1200" dirty="0"/>
          </a:p>
        </p:txBody>
      </p:sp>
      <p:sp>
        <p:nvSpPr>
          <p:cNvPr id="4" name="Title 2"/>
          <p:cNvSpPr txBox="1">
            <a:spLocks/>
          </p:cNvSpPr>
          <p:nvPr/>
        </p:nvSpPr>
        <p:spPr>
          <a:xfrm>
            <a:off x="304800" y="762000"/>
            <a:ext cx="8229600" cy="68580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smtClean="0"/>
              <a:t>PCR Efficiency for Reactions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9223227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2961880461"/>
              </p:ext>
            </p:extLst>
          </p:nvPr>
        </p:nvGraphicFramePr>
        <p:xfrm>
          <a:off x="76200" y="381000"/>
          <a:ext cx="8991600" cy="586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43000" y="6096000"/>
            <a:ext cx="9261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/>
                <a:cs typeface="Arial"/>
              </a:rPr>
              <a:t>* P &lt; 0.05</a:t>
            </a:r>
          </a:p>
          <a:p>
            <a:pPr algn="r"/>
            <a:r>
              <a:rPr lang="en-US" sz="1200" dirty="0" smtClean="0">
                <a:latin typeface="Arial"/>
                <a:cs typeface="Arial"/>
              </a:rPr>
              <a:t>** P &lt; 0.0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878903" y="838200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*</a:t>
            </a:r>
            <a:endParaRPr lang="en-US" b="1" dirty="0">
              <a:latin typeface="Arial"/>
              <a:cs typeface="Arial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4724400" y="533400"/>
            <a:ext cx="609600" cy="5105400"/>
            <a:chOff x="4724400" y="609600"/>
            <a:chExt cx="609600" cy="5105400"/>
          </a:xfrm>
        </p:grpSpPr>
        <p:cxnSp>
          <p:nvCxnSpPr>
            <p:cNvPr id="9" name="Straight Connector 8"/>
            <p:cNvCxnSpPr/>
            <p:nvPr/>
          </p:nvCxnSpPr>
          <p:spPr>
            <a:xfrm>
              <a:off x="5334000" y="609600"/>
              <a:ext cx="0" cy="4495800"/>
            </a:xfrm>
            <a:prstGeom prst="line">
              <a:avLst/>
            </a:prstGeom>
            <a:ln w="38100" cmpd="sng">
              <a:solidFill>
                <a:schemeClr val="accent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H="1">
              <a:off x="4724400" y="5105400"/>
              <a:ext cx="609600" cy="609600"/>
            </a:xfrm>
            <a:prstGeom prst="line">
              <a:avLst/>
            </a:prstGeom>
            <a:ln w="38100" cmpd="sng">
              <a:solidFill>
                <a:srgbClr val="F7964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/>
          <p:cNvGrpSpPr/>
          <p:nvPr/>
        </p:nvGrpSpPr>
        <p:grpSpPr>
          <a:xfrm>
            <a:off x="5907088" y="533400"/>
            <a:ext cx="609600" cy="5105400"/>
            <a:chOff x="4724400" y="609600"/>
            <a:chExt cx="609600" cy="5105400"/>
          </a:xfrm>
        </p:grpSpPr>
        <p:cxnSp>
          <p:nvCxnSpPr>
            <p:cNvPr id="17" name="Straight Connector 16"/>
            <p:cNvCxnSpPr/>
            <p:nvPr/>
          </p:nvCxnSpPr>
          <p:spPr>
            <a:xfrm>
              <a:off x="5334000" y="609600"/>
              <a:ext cx="0" cy="4495800"/>
            </a:xfrm>
            <a:prstGeom prst="line">
              <a:avLst/>
            </a:prstGeom>
            <a:ln w="12700" cmpd="sng">
              <a:solidFill>
                <a:schemeClr val="accent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4724400" y="5105400"/>
              <a:ext cx="609600" cy="609600"/>
            </a:xfrm>
            <a:prstGeom prst="line">
              <a:avLst/>
            </a:prstGeom>
            <a:ln w="12700" cmpd="sng">
              <a:solidFill>
                <a:srgbClr val="F7964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oup 18"/>
          <p:cNvGrpSpPr/>
          <p:nvPr/>
        </p:nvGrpSpPr>
        <p:grpSpPr>
          <a:xfrm>
            <a:off x="6516688" y="533400"/>
            <a:ext cx="609600" cy="5105400"/>
            <a:chOff x="4724400" y="609600"/>
            <a:chExt cx="609600" cy="5105400"/>
          </a:xfrm>
        </p:grpSpPr>
        <p:cxnSp>
          <p:nvCxnSpPr>
            <p:cNvPr id="20" name="Straight Connector 19"/>
            <p:cNvCxnSpPr/>
            <p:nvPr/>
          </p:nvCxnSpPr>
          <p:spPr>
            <a:xfrm>
              <a:off x="5334000" y="609600"/>
              <a:ext cx="0" cy="4495800"/>
            </a:xfrm>
            <a:prstGeom prst="line">
              <a:avLst/>
            </a:prstGeom>
            <a:ln w="12700" cmpd="sng">
              <a:solidFill>
                <a:schemeClr val="accent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>
              <a:off x="4724400" y="5105400"/>
              <a:ext cx="609600" cy="609600"/>
            </a:xfrm>
            <a:prstGeom prst="line">
              <a:avLst/>
            </a:prstGeom>
            <a:ln w="12700" cmpd="sng">
              <a:solidFill>
                <a:srgbClr val="F7964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 21"/>
          <p:cNvGrpSpPr/>
          <p:nvPr/>
        </p:nvGrpSpPr>
        <p:grpSpPr>
          <a:xfrm>
            <a:off x="7696200" y="533400"/>
            <a:ext cx="609600" cy="5105400"/>
            <a:chOff x="4724400" y="609600"/>
            <a:chExt cx="609600" cy="5105400"/>
          </a:xfrm>
        </p:grpSpPr>
        <p:cxnSp>
          <p:nvCxnSpPr>
            <p:cNvPr id="23" name="Straight Connector 22"/>
            <p:cNvCxnSpPr/>
            <p:nvPr/>
          </p:nvCxnSpPr>
          <p:spPr>
            <a:xfrm>
              <a:off x="5334000" y="609600"/>
              <a:ext cx="0" cy="4495800"/>
            </a:xfrm>
            <a:prstGeom prst="line">
              <a:avLst/>
            </a:prstGeom>
            <a:ln w="12700" cmpd="sng">
              <a:solidFill>
                <a:schemeClr val="accent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H="1">
              <a:off x="4724400" y="5105400"/>
              <a:ext cx="609600" cy="609600"/>
            </a:xfrm>
            <a:prstGeom prst="line">
              <a:avLst/>
            </a:prstGeom>
            <a:ln w="12700" cmpd="sng">
              <a:solidFill>
                <a:srgbClr val="F7964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oup 24"/>
          <p:cNvGrpSpPr/>
          <p:nvPr/>
        </p:nvGrpSpPr>
        <p:grpSpPr>
          <a:xfrm>
            <a:off x="2971800" y="533400"/>
            <a:ext cx="609600" cy="5105400"/>
            <a:chOff x="4724400" y="609600"/>
            <a:chExt cx="609600" cy="5105400"/>
          </a:xfrm>
        </p:grpSpPr>
        <p:cxnSp>
          <p:nvCxnSpPr>
            <p:cNvPr id="26" name="Straight Connector 25"/>
            <p:cNvCxnSpPr/>
            <p:nvPr/>
          </p:nvCxnSpPr>
          <p:spPr>
            <a:xfrm>
              <a:off x="5334000" y="609600"/>
              <a:ext cx="0" cy="4495800"/>
            </a:xfrm>
            <a:prstGeom prst="line">
              <a:avLst/>
            </a:prstGeom>
            <a:ln w="12700" cmpd="sng">
              <a:solidFill>
                <a:schemeClr val="accent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 flipH="1">
              <a:off x="4724400" y="5105400"/>
              <a:ext cx="609600" cy="609600"/>
            </a:xfrm>
            <a:prstGeom prst="line">
              <a:avLst/>
            </a:prstGeom>
            <a:ln w="12700" cmpd="sng">
              <a:solidFill>
                <a:srgbClr val="F7964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 27"/>
          <p:cNvGrpSpPr/>
          <p:nvPr/>
        </p:nvGrpSpPr>
        <p:grpSpPr>
          <a:xfrm>
            <a:off x="2362200" y="533400"/>
            <a:ext cx="609600" cy="5105400"/>
            <a:chOff x="4724400" y="609600"/>
            <a:chExt cx="609600" cy="5105400"/>
          </a:xfrm>
        </p:grpSpPr>
        <p:cxnSp>
          <p:nvCxnSpPr>
            <p:cNvPr id="29" name="Straight Connector 28"/>
            <p:cNvCxnSpPr/>
            <p:nvPr/>
          </p:nvCxnSpPr>
          <p:spPr>
            <a:xfrm>
              <a:off x="5334000" y="609600"/>
              <a:ext cx="0" cy="4495800"/>
            </a:xfrm>
            <a:prstGeom prst="line">
              <a:avLst/>
            </a:prstGeom>
            <a:ln w="12700" cmpd="sng">
              <a:solidFill>
                <a:schemeClr val="accent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 flipH="1">
              <a:off x="4724400" y="5105400"/>
              <a:ext cx="609600" cy="609600"/>
            </a:xfrm>
            <a:prstGeom prst="line">
              <a:avLst/>
            </a:prstGeom>
            <a:ln w="12700" cmpd="sng">
              <a:solidFill>
                <a:srgbClr val="F79646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/>
          <p:cNvSpPr txBox="1"/>
          <p:nvPr/>
        </p:nvSpPr>
        <p:spPr>
          <a:xfrm>
            <a:off x="2667000" y="152400"/>
            <a:ext cx="40598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HERV Expression Summary</a:t>
            </a:r>
          </a:p>
          <a:p>
            <a:pPr algn="ctr"/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842337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9729661"/>
              </p:ext>
            </p:extLst>
          </p:nvPr>
        </p:nvGraphicFramePr>
        <p:xfrm>
          <a:off x="514350" y="952500"/>
          <a:ext cx="8115300" cy="4953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26846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17</TotalTime>
  <Words>335</Words>
  <Application>Microsoft Office PowerPoint</Application>
  <PresentationFormat>On-screen Show (4:3)</PresentationFormat>
  <Paragraphs>131</Paragraphs>
  <Slides>8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eeti Aahir</dc:creator>
  <cp:lastModifiedBy>Preeti Aahir</cp:lastModifiedBy>
  <cp:revision>174</cp:revision>
  <dcterms:created xsi:type="dcterms:W3CDTF">2015-09-22T22:29:05Z</dcterms:created>
  <dcterms:modified xsi:type="dcterms:W3CDTF">2016-12-02T20:40:47Z</dcterms:modified>
</cp:coreProperties>
</file>